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  <p:sldMasterId id="2147483672" r:id="rId2"/>
  </p:sldMasterIdLst>
  <p:sldIdLst>
    <p:sldId id="256" r:id="rId3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D65C"/>
    <a:srgbClr val="F590FF"/>
    <a:srgbClr val="AEC500"/>
    <a:srgbClr val="FF9289"/>
    <a:srgbClr val="F0AD00"/>
    <a:srgbClr val="82B7FF"/>
    <a:srgbClr val="FF80DE"/>
    <a:srgbClr val="00D4FF"/>
    <a:srgbClr val="00DCB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125" d="100"/>
          <a:sy n="125" d="100"/>
        </p:scale>
        <p:origin x="2076" y="-11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1.xml"/><Relationship Id="rId7" Type="http://schemas.openxmlformats.org/officeDocument/2006/relationships/tableStyles" Target="tableStyle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D63B68-F50E-4E22-9597-058E5DD41741}" type="datetimeFigureOut">
              <a:rPr lang="zh-CN" altLang="en-US" smtClean="0"/>
              <a:t>2020/8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934BC-4A5B-49D0-B06B-46551841440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725235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D63B68-F50E-4E22-9597-058E5DD41741}" type="datetimeFigureOut">
              <a:rPr lang="zh-CN" altLang="en-US" smtClean="0"/>
              <a:t>2020/8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934BC-4A5B-49D0-B06B-46551841440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160678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D63B68-F50E-4E22-9597-058E5DD41741}" type="datetimeFigureOut">
              <a:rPr lang="zh-CN" altLang="en-US" smtClean="0"/>
              <a:t>2020/8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934BC-4A5B-49D0-B06B-46551841440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57478187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8C0AA3C-A001-4F32-AB06-DAECE0E76D83}" type="datetimeFigureOut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0/8/12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4CC17142-EFC1-4657-B238-3F05A30219BA}" type="slidenum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757251725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8C0AA3C-A001-4F32-AB06-DAECE0E76D83}" type="datetimeFigureOut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0/8/12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4CC17142-EFC1-4657-B238-3F05A30219BA}" type="slidenum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58613340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8C0AA3C-A001-4F32-AB06-DAECE0E76D83}" type="datetimeFigureOut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0/8/12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4CC17142-EFC1-4657-B238-3F05A30219BA}" type="slidenum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335061723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8C0AA3C-A001-4F32-AB06-DAECE0E76D83}" type="datetimeFigureOut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0/8/12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4CC17142-EFC1-4657-B238-3F05A30219BA}" type="slidenum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184418756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8C0AA3C-A001-4F32-AB06-DAECE0E76D83}" type="datetimeFigureOut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0/8/12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4CC17142-EFC1-4657-B238-3F05A30219BA}" type="slidenum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886603557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8C0AA3C-A001-4F32-AB06-DAECE0E76D83}" type="datetimeFigureOut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0/8/12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4CC17142-EFC1-4657-B238-3F05A30219BA}" type="slidenum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474002432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8C0AA3C-A001-4F32-AB06-DAECE0E76D83}" type="datetimeFigureOut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0/8/12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4CC17142-EFC1-4657-B238-3F05A30219BA}" type="slidenum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149919610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8C0AA3C-A001-4F32-AB06-DAECE0E76D83}" type="datetimeFigureOut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0/8/12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4CC17142-EFC1-4657-B238-3F05A30219BA}" type="slidenum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3957004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D63B68-F50E-4E22-9597-058E5DD41741}" type="datetimeFigureOut">
              <a:rPr lang="zh-CN" altLang="en-US" smtClean="0"/>
              <a:t>2020/8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934BC-4A5B-49D0-B06B-46551841440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76975250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8C0AA3C-A001-4F32-AB06-DAECE0E76D83}" type="datetimeFigureOut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0/8/12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4CC17142-EFC1-4657-B238-3F05A30219BA}" type="slidenum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951412458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8C0AA3C-A001-4F32-AB06-DAECE0E76D83}" type="datetimeFigureOut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0/8/12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4CC17142-EFC1-4657-B238-3F05A30219BA}" type="slidenum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90426942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8C0AA3C-A001-4F32-AB06-DAECE0E76D83}" type="datetimeFigureOut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0/8/12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4CC17142-EFC1-4657-B238-3F05A30219BA}" type="slidenum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41752015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D63B68-F50E-4E22-9597-058E5DD41741}" type="datetimeFigureOut">
              <a:rPr lang="zh-CN" altLang="en-US" smtClean="0"/>
              <a:t>2020/8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934BC-4A5B-49D0-B06B-46551841440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641496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D63B68-F50E-4E22-9597-058E5DD41741}" type="datetimeFigureOut">
              <a:rPr lang="zh-CN" altLang="en-US" smtClean="0"/>
              <a:t>2020/8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934BC-4A5B-49D0-B06B-46551841440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223381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D63B68-F50E-4E22-9597-058E5DD41741}" type="datetimeFigureOut">
              <a:rPr lang="zh-CN" altLang="en-US" smtClean="0"/>
              <a:t>2020/8/1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934BC-4A5B-49D0-B06B-46551841440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74185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D63B68-F50E-4E22-9597-058E5DD41741}" type="datetimeFigureOut">
              <a:rPr lang="zh-CN" altLang="en-US" smtClean="0"/>
              <a:t>2020/8/1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934BC-4A5B-49D0-B06B-46551841440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019286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D63B68-F50E-4E22-9597-058E5DD41741}" type="datetimeFigureOut">
              <a:rPr lang="zh-CN" altLang="en-US" smtClean="0"/>
              <a:t>2020/8/1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934BC-4A5B-49D0-B06B-46551841440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600530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D63B68-F50E-4E22-9597-058E5DD41741}" type="datetimeFigureOut">
              <a:rPr lang="zh-CN" altLang="en-US" smtClean="0"/>
              <a:t>2020/8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934BC-4A5B-49D0-B06B-46551841440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364446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D63B68-F50E-4E22-9597-058E5DD41741}" type="datetimeFigureOut">
              <a:rPr lang="zh-CN" altLang="en-US" smtClean="0"/>
              <a:t>2020/8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934BC-4A5B-49D0-B06B-46551841440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726922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D63B68-F50E-4E22-9597-058E5DD41741}" type="datetimeFigureOut">
              <a:rPr lang="zh-CN" altLang="en-US" smtClean="0"/>
              <a:t>2020/8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9934BC-4A5B-49D0-B06B-46551841440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292179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8C0AA3C-A001-4F32-AB06-DAECE0E76D83}" type="datetimeFigureOut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0/8/12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4CC17142-EFC1-4657-B238-3F05A30219BA}" type="slidenum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1219693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图片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99093" y="5278561"/>
            <a:ext cx="4508728" cy="1000000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21142" y="3595206"/>
            <a:ext cx="4487735" cy="1026072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321142" y="2132551"/>
            <a:ext cx="4464989" cy="1052012"/>
          </a:xfrm>
          <a:prstGeom prst="rect">
            <a:avLst/>
          </a:prstGeom>
        </p:spPr>
      </p:pic>
      <p:sp>
        <p:nvSpPr>
          <p:cNvPr id="17" name="文本框 16"/>
          <p:cNvSpPr txBox="1"/>
          <p:nvPr/>
        </p:nvSpPr>
        <p:spPr>
          <a:xfrm rot="10800000">
            <a:off x="674093" y="3665988"/>
            <a:ext cx="430887" cy="1073108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Mutation frequency per </a:t>
            </a:r>
            <a:r>
              <a:rPr kumimoji="0" lang="en-US" altLang="zh-CN" sz="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kb</a:t>
            </a:r>
            <a:endParaRPr kumimoji="0" lang="zh-CN" altLang="en-US" sz="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1019702" y="4480874"/>
            <a:ext cx="4367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0.0</a:t>
            </a:r>
            <a:endParaRPr kumimoji="0" lang="zh-CN" altLang="en-US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1019702" y="4096340"/>
            <a:ext cx="4367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1.0</a:t>
            </a:r>
            <a:endParaRPr kumimoji="0" lang="zh-CN" altLang="en-US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1019702" y="3711804"/>
            <a:ext cx="4367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2.0</a:t>
            </a:r>
            <a:endParaRPr kumimoji="0" lang="zh-CN" altLang="en-US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 rot="10800000">
            <a:off x="694433" y="5143265"/>
            <a:ext cx="430887" cy="134335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Somatic mutation frequency per </a:t>
            </a:r>
            <a:r>
              <a:rPr kumimoji="0" lang="en-US" altLang="zh-CN" sz="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kb</a:t>
            </a:r>
            <a:endParaRPr kumimoji="0" lang="zh-CN" altLang="en-US" sz="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1026820" y="6148546"/>
            <a:ext cx="3812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0.0</a:t>
            </a:r>
            <a:endParaRPr kumimoji="0" lang="zh-CN" altLang="en-US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1026820" y="5672299"/>
            <a:ext cx="3812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1.0</a:t>
            </a:r>
            <a:endParaRPr kumimoji="0" lang="zh-CN" altLang="en-US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1026820" y="5196052"/>
            <a:ext cx="3812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2.0</a:t>
            </a:r>
            <a:endParaRPr kumimoji="0" lang="zh-CN" altLang="en-US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1026064" y="2792464"/>
            <a:ext cx="3812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10</a:t>
            </a:r>
            <a:endParaRPr kumimoji="0" lang="zh-CN" altLang="en-US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1026064" y="2298384"/>
            <a:ext cx="3812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30</a:t>
            </a:r>
            <a:endParaRPr kumimoji="0" lang="zh-CN" altLang="en-US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1026064" y="2545424"/>
            <a:ext cx="3812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20</a:t>
            </a:r>
            <a:endParaRPr kumimoji="0" lang="zh-CN" altLang="en-US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1026064" y="2051344"/>
            <a:ext cx="3812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40</a:t>
            </a:r>
            <a:endParaRPr kumimoji="0" lang="zh-CN" altLang="en-US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 rot="10800000">
            <a:off x="674092" y="2220444"/>
            <a:ext cx="430887" cy="934358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SNV </a:t>
            </a:r>
            <a:r>
              <a:rPr kumimoji="0" lang="en-US" altLang="zh-CN" sz="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frequency 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er </a:t>
            </a:r>
            <a:r>
              <a:rPr kumimoji="0" lang="en-US" altLang="zh-CN" sz="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kb</a:t>
            </a:r>
            <a:endParaRPr kumimoji="0" lang="zh-CN" altLang="en-US" sz="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grpSp>
        <p:nvGrpSpPr>
          <p:cNvPr id="5" name="Group 4"/>
          <p:cNvGrpSpPr/>
          <p:nvPr/>
        </p:nvGrpSpPr>
        <p:grpSpPr>
          <a:xfrm>
            <a:off x="1366869" y="3116822"/>
            <a:ext cx="4405509" cy="215444"/>
            <a:chOff x="1411318" y="1870924"/>
            <a:chExt cx="4405509" cy="215444"/>
          </a:xfrm>
        </p:grpSpPr>
        <p:sp>
          <p:nvSpPr>
            <p:cNvPr id="30" name="文本框 29"/>
            <p:cNvSpPr txBox="1"/>
            <p:nvPr/>
          </p:nvSpPr>
          <p:spPr>
            <a:xfrm>
              <a:off x="2656278" y="1870924"/>
              <a:ext cx="13838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Autosomes 1 to 22</a:t>
              </a:r>
              <a:endParaRPr kumimoji="0" lang="zh-CN" altLang="en-US" sz="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cxnSp>
          <p:nvCxnSpPr>
            <p:cNvPr id="29" name="直接连接符 28"/>
            <p:cNvCxnSpPr/>
            <p:nvPr/>
          </p:nvCxnSpPr>
          <p:spPr>
            <a:xfrm>
              <a:off x="1420034" y="1936177"/>
              <a:ext cx="0" cy="1157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直接箭头连接符 30"/>
            <p:cNvCxnSpPr/>
            <p:nvPr/>
          </p:nvCxnSpPr>
          <p:spPr>
            <a:xfrm flipV="1">
              <a:off x="4143621" y="1994034"/>
              <a:ext cx="1223993" cy="1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arrow"/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直接箭头连接符 31"/>
            <p:cNvCxnSpPr/>
            <p:nvPr/>
          </p:nvCxnSpPr>
          <p:spPr>
            <a:xfrm flipH="1">
              <a:off x="1411318" y="1990531"/>
              <a:ext cx="1223993" cy="7007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arrow"/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文本框 32"/>
            <p:cNvSpPr txBox="1"/>
            <p:nvPr/>
          </p:nvSpPr>
          <p:spPr>
            <a:xfrm>
              <a:off x="5436131" y="1870924"/>
              <a:ext cx="19401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X</a:t>
              </a:r>
              <a:endParaRPr kumimoji="0" lang="zh-CN" altLang="en-US" sz="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4" name="文本框 33"/>
            <p:cNvSpPr txBox="1"/>
            <p:nvPr/>
          </p:nvSpPr>
          <p:spPr>
            <a:xfrm>
              <a:off x="5622816" y="1870924"/>
              <a:ext cx="19401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Y</a:t>
              </a:r>
              <a:endParaRPr kumimoji="0" lang="zh-CN" altLang="en-US" sz="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cxnSp>
          <p:nvCxnSpPr>
            <p:cNvPr id="36" name="直接连接符 35"/>
            <p:cNvCxnSpPr/>
            <p:nvPr/>
          </p:nvCxnSpPr>
          <p:spPr>
            <a:xfrm>
              <a:off x="5393283" y="1936177"/>
              <a:ext cx="0" cy="1157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6" name="TextBox 7"/>
          <p:cNvSpPr txBox="1"/>
          <p:nvPr/>
        </p:nvSpPr>
        <p:spPr>
          <a:xfrm>
            <a:off x="724954" y="1876152"/>
            <a:ext cx="1971237" cy="250610"/>
          </a:xfrm>
          <a:prstGeom prst="rect">
            <a:avLst/>
          </a:prstGeom>
          <a:noFill/>
        </p:spPr>
        <p:txBody>
          <a:bodyPr wrap="none" lIns="65306" tIns="32653" rIns="65306" bIns="32653" rtlCol="0">
            <a:spAutoFit/>
          </a:bodyPr>
          <a:lstStyle/>
          <a:p>
            <a:pPr>
              <a:defRPr/>
            </a:pPr>
            <a:r>
              <a:rPr lang="en-US" sz="12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  </a:t>
            </a:r>
            <a:r>
              <a:rPr lang="en-US" altLang="zh-CN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0 Genomes P</a:t>
            </a:r>
            <a:r>
              <a:rPr lang="en-US" altLang="zh-CN" sz="12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oject</a:t>
            </a:r>
            <a:endParaRPr lang="en-US" altLang="zh-CN" sz="12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" name="组合 7"/>
          <p:cNvGrpSpPr/>
          <p:nvPr/>
        </p:nvGrpSpPr>
        <p:grpSpPr>
          <a:xfrm>
            <a:off x="1388459" y="4550987"/>
            <a:ext cx="4366316" cy="253752"/>
            <a:chOff x="1388459" y="4538287"/>
            <a:chExt cx="4366316" cy="253752"/>
          </a:xfrm>
        </p:grpSpPr>
        <p:sp>
          <p:nvSpPr>
            <p:cNvPr id="67" name="文本框 29"/>
            <p:cNvSpPr txBox="1"/>
            <p:nvPr/>
          </p:nvSpPr>
          <p:spPr>
            <a:xfrm>
              <a:off x="2633419" y="4538287"/>
              <a:ext cx="13838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Autosomes 1 to 22</a:t>
              </a:r>
              <a:endParaRPr kumimoji="0" lang="zh-CN" altLang="en-US" sz="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cxnSp>
          <p:nvCxnSpPr>
            <p:cNvPr id="68" name="直接连接符 28"/>
            <p:cNvCxnSpPr/>
            <p:nvPr/>
          </p:nvCxnSpPr>
          <p:spPr>
            <a:xfrm>
              <a:off x="1397175" y="4603540"/>
              <a:ext cx="0" cy="1157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直接箭头连接符 30"/>
            <p:cNvCxnSpPr/>
            <p:nvPr/>
          </p:nvCxnSpPr>
          <p:spPr>
            <a:xfrm flipV="1">
              <a:off x="4108062" y="4661397"/>
              <a:ext cx="1223993" cy="1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arrow"/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直接箭头连接符 31"/>
            <p:cNvCxnSpPr/>
            <p:nvPr/>
          </p:nvCxnSpPr>
          <p:spPr>
            <a:xfrm flipH="1">
              <a:off x="1388459" y="4657894"/>
              <a:ext cx="1223993" cy="7007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arrow"/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1" name="文本框 32"/>
            <p:cNvSpPr txBox="1"/>
            <p:nvPr/>
          </p:nvSpPr>
          <p:spPr>
            <a:xfrm>
              <a:off x="5389143" y="4576595"/>
              <a:ext cx="19401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X</a:t>
              </a:r>
              <a:endParaRPr kumimoji="0" lang="zh-CN" altLang="en-US" sz="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72" name="文本框 33"/>
            <p:cNvSpPr txBox="1"/>
            <p:nvPr/>
          </p:nvSpPr>
          <p:spPr>
            <a:xfrm>
              <a:off x="5560764" y="4576595"/>
              <a:ext cx="19401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Y</a:t>
              </a:r>
              <a:endParaRPr kumimoji="0" lang="zh-CN" altLang="en-US" sz="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cxnSp>
          <p:nvCxnSpPr>
            <p:cNvPr id="73" name="直接连接符 35"/>
            <p:cNvCxnSpPr/>
            <p:nvPr/>
          </p:nvCxnSpPr>
          <p:spPr>
            <a:xfrm>
              <a:off x="5351374" y="4603540"/>
              <a:ext cx="0" cy="1157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5" name="组合 14"/>
          <p:cNvGrpSpPr/>
          <p:nvPr/>
        </p:nvGrpSpPr>
        <p:grpSpPr>
          <a:xfrm>
            <a:off x="1379569" y="6244974"/>
            <a:ext cx="4405509" cy="215444"/>
            <a:chOff x="1379569" y="6244974"/>
            <a:chExt cx="4405509" cy="215444"/>
          </a:xfrm>
        </p:grpSpPr>
        <p:sp>
          <p:nvSpPr>
            <p:cNvPr id="75" name="文本框 29"/>
            <p:cNvSpPr txBox="1"/>
            <p:nvPr/>
          </p:nvSpPr>
          <p:spPr>
            <a:xfrm>
              <a:off x="2656279" y="6244974"/>
              <a:ext cx="13838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Autosomes 1 to 22</a:t>
              </a:r>
              <a:endParaRPr kumimoji="0" lang="zh-CN" altLang="en-US" sz="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cxnSp>
          <p:nvCxnSpPr>
            <p:cNvPr id="76" name="直接连接符 28"/>
            <p:cNvCxnSpPr/>
            <p:nvPr/>
          </p:nvCxnSpPr>
          <p:spPr>
            <a:xfrm>
              <a:off x="1388285" y="6310227"/>
              <a:ext cx="0" cy="1157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直接箭头连接符 30"/>
            <p:cNvCxnSpPr/>
            <p:nvPr/>
          </p:nvCxnSpPr>
          <p:spPr>
            <a:xfrm flipV="1">
              <a:off x="4143622" y="6368084"/>
              <a:ext cx="1223993" cy="1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arrow"/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直接箭头连接符 31"/>
            <p:cNvCxnSpPr/>
            <p:nvPr/>
          </p:nvCxnSpPr>
          <p:spPr>
            <a:xfrm flipH="1">
              <a:off x="1379569" y="6364581"/>
              <a:ext cx="1223993" cy="7007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arrow"/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9" name="文本框 32"/>
            <p:cNvSpPr txBox="1"/>
            <p:nvPr/>
          </p:nvSpPr>
          <p:spPr>
            <a:xfrm>
              <a:off x="5404381" y="6244974"/>
              <a:ext cx="19401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X</a:t>
              </a:r>
              <a:endParaRPr kumimoji="0" lang="zh-CN" altLang="en-US" sz="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80" name="文本框 33"/>
            <p:cNvSpPr txBox="1"/>
            <p:nvPr/>
          </p:nvSpPr>
          <p:spPr>
            <a:xfrm>
              <a:off x="5591067" y="6244974"/>
              <a:ext cx="19401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Y</a:t>
              </a:r>
              <a:endParaRPr kumimoji="0" lang="zh-CN" altLang="en-US" sz="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cxnSp>
          <p:nvCxnSpPr>
            <p:cNvPr id="81" name="直接连接符 35"/>
            <p:cNvCxnSpPr/>
            <p:nvPr/>
          </p:nvCxnSpPr>
          <p:spPr>
            <a:xfrm>
              <a:off x="5380584" y="6310227"/>
              <a:ext cx="0" cy="11571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83" name="TextBox 7"/>
          <p:cNvSpPr txBox="1"/>
          <p:nvPr/>
        </p:nvSpPr>
        <p:spPr>
          <a:xfrm>
            <a:off x="724954" y="3343852"/>
            <a:ext cx="902483" cy="250610"/>
          </a:xfrm>
          <a:prstGeom prst="rect">
            <a:avLst/>
          </a:prstGeom>
          <a:noFill/>
        </p:spPr>
        <p:txBody>
          <a:bodyPr wrap="none" lIns="65306" tIns="32653" rIns="65306" bIns="32653" rtlCol="0">
            <a:spAutoFit/>
          </a:bodyPr>
          <a:lstStyle/>
          <a:p>
            <a:pPr>
              <a:defRPr/>
            </a:pPr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  </a:t>
            </a:r>
            <a:r>
              <a:rPr lang="en-US" altLang="zh-CN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b="1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linVar</a:t>
            </a:r>
            <a:endParaRPr lang="en-US" altLang="zh-CN" sz="12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7"/>
          <p:cNvSpPr txBox="1"/>
          <p:nvPr/>
        </p:nvSpPr>
        <p:spPr>
          <a:xfrm>
            <a:off x="717334" y="4996580"/>
            <a:ext cx="2237336" cy="250610"/>
          </a:xfrm>
          <a:prstGeom prst="rect">
            <a:avLst/>
          </a:prstGeom>
          <a:noFill/>
        </p:spPr>
        <p:txBody>
          <a:bodyPr wrap="none" lIns="65306" tIns="32653" rIns="65306" bIns="32653" rtlCol="0">
            <a:spAutoFit/>
          </a:bodyPr>
          <a:lstStyle/>
          <a:p>
            <a:pPr>
              <a:defRPr/>
            </a:pPr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  </a:t>
            </a:r>
            <a:r>
              <a:rPr lang="en-US" altLang="zh-CN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 Cancer Genome Atlas</a:t>
            </a:r>
          </a:p>
        </p:txBody>
      </p:sp>
      <p:grpSp>
        <p:nvGrpSpPr>
          <p:cNvPr id="2" name="组合 1"/>
          <p:cNvGrpSpPr/>
          <p:nvPr/>
        </p:nvGrpSpPr>
        <p:grpSpPr>
          <a:xfrm>
            <a:off x="4529989" y="1908228"/>
            <a:ext cx="1505514" cy="386445"/>
            <a:chOff x="4529989" y="1017931"/>
            <a:chExt cx="1165775" cy="386445"/>
          </a:xfrm>
        </p:grpSpPr>
        <p:sp>
          <p:nvSpPr>
            <p:cNvPr id="39" name="矩形 38"/>
            <p:cNvSpPr/>
            <p:nvPr/>
          </p:nvSpPr>
          <p:spPr>
            <a:xfrm>
              <a:off x="4529989" y="1071639"/>
              <a:ext cx="100422" cy="93600"/>
            </a:xfrm>
            <a:prstGeom prst="rect">
              <a:avLst/>
            </a:prstGeom>
            <a:solidFill>
              <a:srgbClr val="C0C0C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40" name="矩形 39"/>
            <p:cNvSpPr/>
            <p:nvPr/>
          </p:nvSpPr>
          <p:spPr>
            <a:xfrm>
              <a:off x="4529989" y="1257225"/>
              <a:ext cx="100422" cy="9360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8" name="文本框 37"/>
            <p:cNvSpPr txBox="1"/>
            <p:nvPr/>
          </p:nvSpPr>
          <p:spPr>
            <a:xfrm>
              <a:off x="4630408" y="1017931"/>
              <a:ext cx="10399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Non-MCR region</a:t>
              </a:r>
              <a:endParaRPr kumimoji="0" lang="en-US" altLang="zh-CN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82" name="文本框 37"/>
            <p:cNvSpPr txBox="1"/>
            <p:nvPr/>
          </p:nvSpPr>
          <p:spPr>
            <a:xfrm>
              <a:off x="4630408" y="1188932"/>
              <a:ext cx="106535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MCR region</a:t>
              </a:r>
              <a:endParaRPr kumimoji="0" lang="en-US" altLang="zh-CN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</p:grpSp>
      <p:sp>
        <p:nvSpPr>
          <p:cNvPr id="52" name="文本框 51"/>
          <p:cNvSpPr txBox="1"/>
          <p:nvPr/>
        </p:nvSpPr>
        <p:spPr>
          <a:xfrm>
            <a:off x="1026064" y="3039503"/>
            <a:ext cx="3812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0</a:t>
            </a:r>
            <a:endParaRPr kumimoji="0" lang="zh-CN" altLang="en-US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56" name="文本框 55"/>
          <p:cNvSpPr txBox="1"/>
          <p:nvPr/>
        </p:nvSpPr>
        <p:spPr>
          <a:xfrm>
            <a:off x="1019702" y="4288608"/>
            <a:ext cx="4367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0.5</a:t>
            </a:r>
            <a:endParaRPr kumimoji="0" lang="zh-CN" altLang="en-US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57" name="文本框 56"/>
          <p:cNvSpPr txBox="1"/>
          <p:nvPr/>
        </p:nvSpPr>
        <p:spPr>
          <a:xfrm>
            <a:off x="1019702" y="3904072"/>
            <a:ext cx="4367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800" dirty="0" smtClean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1.5</a:t>
            </a:r>
            <a:endParaRPr kumimoji="0" lang="zh-CN" altLang="en-US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58" name="文本框 57"/>
          <p:cNvSpPr txBox="1"/>
          <p:nvPr/>
        </p:nvSpPr>
        <p:spPr>
          <a:xfrm>
            <a:off x="1019702" y="3519536"/>
            <a:ext cx="4367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800" dirty="0" smtClean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2.5</a:t>
            </a:r>
            <a:endParaRPr kumimoji="0" lang="zh-CN" altLang="en-US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61" name="文本框 60"/>
          <p:cNvSpPr txBox="1"/>
          <p:nvPr/>
        </p:nvSpPr>
        <p:spPr>
          <a:xfrm>
            <a:off x="1026820" y="5910422"/>
            <a:ext cx="3812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0.5</a:t>
            </a:r>
            <a:endParaRPr kumimoji="0" lang="zh-CN" altLang="en-US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62" name="文本框 61"/>
          <p:cNvSpPr txBox="1"/>
          <p:nvPr/>
        </p:nvSpPr>
        <p:spPr>
          <a:xfrm>
            <a:off x="1026820" y="5434176"/>
            <a:ext cx="3812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800" dirty="0" smtClean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1.5</a:t>
            </a:r>
            <a:endParaRPr kumimoji="0" lang="zh-CN" altLang="en-US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526604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54</TotalTime>
  <Words>62</Words>
  <Application>Microsoft Office PowerPoint</Application>
  <PresentationFormat>A4 纸张(210x297 毫米)</PresentationFormat>
  <Paragraphs>3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2</vt:i4>
      </vt:variant>
      <vt:variant>
        <vt:lpstr>幻灯片标题</vt:lpstr>
      </vt:variant>
      <vt:variant>
        <vt:i4>1</vt:i4>
      </vt:variant>
    </vt:vector>
  </HeadingPairs>
  <TitlesOfParts>
    <vt:vector size="9" baseType="lpstr">
      <vt:lpstr>等线</vt:lpstr>
      <vt:lpstr>等线 Light</vt:lpstr>
      <vt:lpstr>宋体</vt:lpstr>
      <vt:lpstr>Arial</vt:lpstr>
      <vt:lpstr>Calibri</vt:lpstr>
      <vt:lpstr>Calibri Light</vt:lpstr>
      <vt:lpstr>Office 主题​​</vt:lpstr>
      <vt:lpstr>1_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张 艳芳</dc:creator>
  <cp:lastModifiedBy>张 艳芳</cp:lastModifiedBy>
  <cp:revision>31</cp:revision>
  <dcterms:created xsi:type="dcterms:W3CDTF">2018-12-08T09:09:22Z</dcterms:created>
  <dcterms:modified xsi:type="dcterms:W3CDTF">2020-08-12T15:28:49Z</dcterms:modified>
</cp:coreProperties>
</file>